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-354" y="-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ENG\SkyDrive\Fine%20mapping%20and%20cytoplasmic%20analysis\11-7-2012\11-7%20%202006,%202008%2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386351706036746"/>
          <c:y val="1.6856436384057129E-2"/>
          <c:w val="0.83779615048118983"/>
          <c:h val="0.94567141544409927"/>
        </c:manualLayout>
      </c:layout>
      <c:barChart>
        <c:barDir val="bar"/>
        <c:grouping val="clustered"/>
        <c:varyColors val="0"/>
        <c:ser>
          <c:idx val="0"/>
          <c:order val="0"/>
          <c:invertIfNegative val="0"/>
          <c:cat>
            <c:strRef>
              <c:f>株高!$A$3:$A$32</c:f>
              <c:strCache>
                <c:ptCount val="30"/>
                <c:pt idx="0">
                  <c:v>A1/R1</c:v>
                </c:pt>
                <c:pt idx="1">
                  <c:v>A2/R1</c:v>
                </c:pt>
                <c:pt idx="2">
                  <c:v>A3/R1</c:v>
                </c:pt>
                <c:pt idx="3">
                  <c:v>A4/R1</c:v>
                </c:pt>
                <c:pt idx="4">
                  <c:v>A5/R1</c:v>
                </c:pt>
                <c:pt idx="5">
                  <c:v>A6/R1</c:v>
                </c:pt>
                <c:pt idx="6">
                  <c:v>A1/R2</c:v>
                </c:pt>
                <c:pt idx="7">
                  <c:v>A2/R2</c:v>
                </c:pt>
                <c:pt idx="8">
                  <c:v>A3/R2</c:v>
                </c:pt>
                <c:pt idx="9">
                  <c:v>A4/R2</c:v>
                </c:pt>
                <c:pt idx="10">
                  <c:v>A5/R2</c:v>
                </c:pt>
                <c:pt idx="11">
                  <c:v>A6/R2</c:v>
                </c:pt>
                <c:pt idx="12">
                  <c:v>A1/R3</c:v>
                </c:pt>
                <c:pt idx="13">
                  <c:v>A2/R3</c:v>
                </c:pt>
                <c:pt idx="14">
                  <c:v>A3/R3</c:v>
                </c:pt>
                <c:pt idx="15">
                  <c:v>A4/R3</c:v>
                </c:pt>
                <c:pt idx="16">
                  <c:v>A5/R3</c:v>
                </c:pt>
                <c:pt idx="17">
                  <c:v>A6/R3</c:v>
                </c:pt>
                <c:pt idx="18">
                  <c:v>A1/R4</c:v>
                </c:pt>
                <c:pt idx="19">
                  <c:v>A2/R4</c:v>
                </c:pt>
                <c:pt idx="20">
                  <c:v>A3/R4</c:v>
                </c:pt>
                <c:pt idx="21">
                  <c:v>A4/R4</c:v>
                </c:pt>
                <c:pt idx="22">
                  <c:v>A5/R4</c:v>
                </c:pt>
                <c:pt idx="23">
                  <c:v>A6/R4</c:v>
                </c:pt>
                <c:pt idx="24">
                  <c:v>A1/R5</c:v>
                </c:pt>
                <c:pt idx="25">
                  <c:v>A2/R5</c:v>
                </c:pt>
                <c:pt idx="26">
                  <c:v>A3/R5</c:v>
                </c:pt>
                <c:pt idx="27">
                  <c:v>A4/R5</c:v>
                </c:pt>
                <c:pt idx="28">
                  <c:v>A5/R5</c:v>
                </c:pt>
                <c:pt idx="29">
                  <c:v>A6/R5</c:v>
                </c:pt>
              </c:strCache>
            </c:strRef>
          </c:cat>
          <c:val>
            <c:numRef>
              <c:f>株高!$E$3:$E$32</c:f>
              <c:numCache>
                <c:formatCode>0.0;_⠀</c:formatCode>
                <c:ptCount val="30"/>
                <c:pt idx="0">
                  <c:v>124.86666666666667</c:v>
                </c:pt>
                <c:pt idx="1">
                  <c:v>119.19999999999999</c:v>
                </c:pt>
                <c:pt idx="2">
                  <c:v>121.46666666666665</c:v>
                </c:pt>
                <c:pt idx="3">
                  <c:v>122.04074074074067</c:v>
                </c:pt>
                <c:pt idx="4">
                  <c:v>122.36666666666667</c:v>
                </c:pt>
                <c:pt idx="5">
                  <c:v>123.26666666666665</c:v>
                </c:pt>
                <c:pt idx="6">
                  <c:v>122.77777777777777</c:v>
                </c:pt>
                <c:pt idx="7">
                  <c:v>121.36666666666667</c:v>
                </c:pt>
                <c:pt idx="8">
                  <c:v>118.8</c:v>
                </c:pt>
                <c:pt idx="9">
                  <c:v>120.66666666666667</c:v>
                </c:pt>
                <c:pt idx="10">
                  <c:v>119.86666666666667</c:v>
                </c:pt>
                <c:pt idx="11">
                  <c:v>121.01555555555568</c:v>
                </c:pt>
                <c:pt idx="12">
                  <c:v>117.04</c:v>
                </c:pt>
                <c:pt idx="13">
                  <c:v>118.63333333333333</c:v>
                </c:pt>
                <c:pt idx="14">
                  <c:v>118.7</c:v>
                </c:pt>
                <c:pt idx="15">
                  <c:v>117.7</c:v>
                </c:pt>
                <c:pt idx="16">
                  <c:v>115.90000000000002</c:v>
                </c:pt>
                <c:pt idx="17">
                  <c:v>116.23481481481467</c:v>
                </c:pt>
                <c:pt idx="18">
                  <c:v>116.09999999999998</c:v>
                </c:pt>
                <c:pt idx="19">
                  <c:v>115.23333333333333</c:v>
                </c:pt>
                <c:pt idx="20">
                  <c:v>115.06666666666666</c:v>
                </c:pt>
                <c:pt idx="21">
                  <c:v>115.44444444444444</c:v>
                </c:pt>
                <c:pt idx="22">
                  <c:v>114.53333333333335</c:v>
                </c:pt>
                <c:pt idx="23">
                  <c:v>115.04074074074067</c:v>
                </c:pt>
                <c:pt idx="24">
                  <c:v>121.83333333333333</c:v>
                </c:pt>
                <c:pt idx="25">
                  <c:v>118.10000000000001</c:v>
                </c:pt>
                <c:pt idx="26">
                  <c:v>117.73333333333333</c:v>
                </c:pt>
                <c:pt idx="27">
                  <c:v>118.16666666666667</c:v>
                </c:pt>
                <c:pt idx="28">
                  <c:v>118.26666666666667</c:v>
                </c:pt>
                <c:pt idx="29">
                  <c:v>119.80740740740741</c:v>
                </c:pt>
              </c:numCache>
            </c:numRef>
          </c:val>
        </c:ser>
        <c:ser>
          <c:idx val="1"/>
          <c:order val="1"/>
          <c:invertIfNegative val="0"/>
          <c:cat>
            <c:strRef>
              <c:f>株高!$A$3:$A$32</c:f>
              <c:strCache>
                <c:ptCount val="30"/>
                <c:pt idx="0">
                  <c:v>A1/R1</c:v>
                </c:pt>
                <c:pt idx="1">
                  <c:v>A2/R1</c:v>
                </c:pt>
                <c:pt idx="2">
                  <c:v>A3/R1</c:v>
                </c:pt>
                <c:pt idx="3">
                  <c:v>A4/R1</c:v>
                </c:pt>
                <c:pt idx="4">
                  <c:v>A5/R1</c:v>
                </c:pt>
                <c:pt idx="5">
                  <c:v>A6/R1</c:v>
                </c:pt>
                <c:pt idx="6">
                  <c:v>A1/R2</c:v>
                </c:pt>
                <c:pt idx="7">
                  <c:v>A2/R2</c:v>
                </c:pt>
                <c:pt idx="8">
                  <c:v>A3/R2</c:v>
                </c:pt>
                <c:pt idx="9">
                  <c:v>A4/R2</c:v>
                </c:pt>
                <c:pt idx="10">
                  <c:v>A5/R2</c:v>
                </c:pt>
                <c:pt idx="11">
                  <c:v>A6/R2</c:v>
                </c:pt>
                <c:pt idx="12">
                  <c:v>A1/R3</c:v>
                </c:pt>
                <c:pt idx="13">
                  <c:v>A2/R3</c:v>
                </c:pt>
                <c:pt idx="14">
                  <c:v>A3/R3</c:v>
                </c:pt>
                <c:pt idx="15">
                  <c:v>A4/R3</c:v>
                </c:pt>
                <c:pt idx="16">
                  <c:v>A5/R3</c:v>
                </c:pt>
                <c:pt idx="17">
                  <c:v>A6/R3</c:v>
                </c:pt>
                <c:pt idx="18">
                  <c:v>A1/R4</c:v>
                </c:pt>
                <c:pt idx="19">
                  <c:v>A2/R4</c:v>
                </c:pt>
                <c:pt idx="20">
                  <c:v>A3/R4</c:v>
                </c:pt>
                <c:pt idx="21">
                  <c:v>A4/R4</c:v>
                </c:pt>
                <c:pt idx="22">
                  <c:v>A5/R4</c:v>
                </c:pt>
                <c:pt idx="23">
                  <c:v>A6/R4</c:v>
                </c:pt>
                <c:pt idx="24">
                  <c:v>A1/R5</c:v>
                </c:pt>
                <c:pt idx="25">
                  <c:v>A2/R5</c:v>
                </c:pt>
                <c:pt idx="26">
                  <c:v>A3/R5</c:v>
                </c:pt>
                <c:pt idx="27">
                  <c:v>A4/R5</c:v>
                </c:pt>
                <c:pt idx="28">
                  <c:v>A5/R5</c:v>
                </c:pt>
                <c:pt idx="29">
                  <c:v>A6/R5</c:v>
                </c:pt>
              </c:strCache>
            </c:strRef>
          </c:cat>
          <c:val>
            <c:numRef>
              <c:f>株高!$N$3:$N$32</c:f>
              <c:numCache>
                <c:formatCode>General</c:formatCode>
                <c:ptCount val="30"/>
                <c:pt idx="0">
                  <c:v>128.72963044538702</c:v>
                </c:pt>
                <c:pt idx="1">
                  <c:v>120.80697702940127</c:v>
                </c:pt>
                <c:pt idx="2">
                  <c:v>124.66677993202607</c:v>
                </c:pt>
                <c:pt idx="3">
                  <c:v>129.40223170642017</c:v>
                </c:pt>
                <c:pt idx="4">
                  <c:v>128.56776333165053</c:v>
                </c:pt>
                <c:pt idx="5">
                  <c:v>129.27209672987053</c:v>
                </c:pt>
                <c:pt idx="6">
                  <c:v>122.78621203378884</c:v>
                </c:pt>
                <c:pt idx="7">
                  <c:v>122.20137802289101</c:v>
                </c:pt>
                <c:pt idx="8">
                  <c:v>122.14432817969339</c:v>
                </c:pt>
                <c:pt idx="9">
                  <c:v>125.534191666106</c:v>
                </c:pt>
                <c:pt idx="10">
                  <c:v>125.41117801988401</c:v>
                </c:pt>
                <c:pt idx="11">
                  <c:v>122.44470506671276</c:v>
                </c:pt>
                <c:pt idx="12">
                  <c:v>121.99887843820561</c:v>
                </c:pt>
                <c:pt idx="13">
                  <c:v>120.85684532180484</c:v>
                </c:pt>
                <c:pt idx="14">
                  <c:v>126.78032071313514</c:v>
                </c:pt>
                <c:pt idx="15">
                  <c:v>120.82347314316688</c:v>
                </c:pt>
                <c:pt idx="16">
                  <c:v>120.16420774957243</c:v>
                </c:pt>
                <c:pt idx="17">
                  <c:v>118.26332565074125</c:v>
                </c:pt>
                <c:pt idx="18">
                  <c:v>117.8717659533782</c:v>
                </c:pt>
                <c:pt idx="19">
                  <c:v>121.01558721598606</c:v>
                </c:pt>
                <c:pt idx="20">
                  <c:v>116.7848073839309</c:v>
                </c:pt>
                <c:pt idx="21">
                  <c:v>122.73598119930671</c:v>
                </c:pt>
                <c:pt idx="22">
                  <c:v>121.44514529830805</c:v>
                </c:pt>
                <c:pt idx="23">
                  <c:v>112.61359520135581</c:v>
                </c:pt>
                <c:pt idx="24">
                  <c:v>130.17495127341047</c:v>
                </c:pt>
                <c:pt idx="25">
                  <c:v>117.89793350197488</c:v>
                </c:pt>
                <c:pt idx="26">
                  <c:v>115.28637809714776</c:v>
                </c:pt>
                <c:pt idx="27">
                  <c:v>126.43481639985576</c:v>
                </c:pt>
                <c:pt idx="28">
                  <c:v>126.87043369926987</c:v>
                </c:pt>
                <c:pt idx="29">
                  <c:v>118.9776172121718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21413376"/>
        <c:axId val="253776640"/>
      </c:barChart>
      <c:catAx>
        <c:axId val="221413376"/>
        <c:scaling>
          <c:orientation val="minMax"/>
        </c:scaling>
        <c:delete val="0"/>
        <c:axPos val="l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253776640"/>
        <c:crosses val="autoZero"/>
        <c:auto val="1"/>
        <c:lblAlgn val="ctr"/>
        <c:lblOffset val="100"/>
        <c:noMultiLvlLbl val="0"/>
      </c:catAx>
      <c:valAx>
        <c:axId val="253776640"/>
        <c:scaling>
          <c:orientation val="minMax"/>
        </c:scaling>
        <c:delete val="0"/>
        <c:axPos val="b"/>
        <c:numFmt formatCode="0.0;_⠀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22141337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39240968"/>
              </p:ext>
            </p:extLst>
          </p:nvPr>
        </p:nvGraphicFramePr>
        <p:xfrm>
          <a:off x="381000" y="400111"/>
          <a:ext cx="5334000" cy="82427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981200" y="8697295"/>
            <a:ext cx="2133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Plant height </a:t>
            </a:r>
            <a:r>
              <a:rPr lang="en-US" altLang="zh-CN" b="1" dirty="0" smtClean="0"/>
              <a:t>(cm)</a:t>
            </a:r>
            <a:endParaRPr lang="en-US" b="1" dirty="0"/>
          </a:p>
        </p:txBody>
      </p:sp>
      <p:sp>
        <p:nvSpPr>
          <p:cNvPr id="94" name="TextBox 93"/>
          <p:cNvSpPr txBox="1"/>
          <p:nvPr/>
        </p:nvSpPr>
        <p:spPr>
          <a:xfrm>
            <a:off x="5105400" y="56315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54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8</a:t>
            </a:r>
            <a:r>
              <a:rPr lang="en-US" altLang="zh-CN" sz="800" spc="-10" dirty="0" smtClean="0"/>
              <a:t>.22</a:t>
            </a:r>
            <a:endParaRPr lang="en-US" sz="800" spc="-10" dirty="0"/>
          </a:p>
        </p:txBody>
      </p:sp>
      <p:sp>
        <p:nvSpPr>
          <p:cNvPr id="95" name="TextBox 94"/>
          <p:cNvSpPr txBox="1"/>
          <p:nvPr/>
        </p:nvSpPr>
        <p:spPr>
          <a:xfrm>
            <a:off x="5105400" y="1343578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0</a:t>
            </a:r>
            <a:r>
              <a:rPr lang="en-US" altLang="zh-CN" sz="800" spc="-10" dirty="0" smtClean="0"/>
              <a:t>.63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58</a:t>
            </a:r>
            <a:endParaRPr lang="en-US" sz="800" spc="-10" dirty="0"/>
          </a:p>
        </p:txBody>
      </p:sp>
      <p:sp>
        <p:nvSpPr>
          <p:cNvPr id="96" name="TextBox 95"/>
          <p:cNvSpPr txBox="1"/>
          <p:nvPr/>
        </p:nvSpPr>
        <p:spPr>
          <a:xfrm>
            <a:off x="5105400" y="82329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86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97</a:t>
            </a:r>
            <a:endParaRPr lang="en-US" sz="800" spc="-10" dirty="0"/>
          </a:p>
        </p:txBody>
      </p:sp>
      <p:sp>
        <p:nvSpPr>
          <p:cNvPr id="97" name="TextBox 96"/>
          <p:cNvSpPr txBox="1"/>
          <p:nvPr/>
        </p:nvSpPr>
        <p:spPr>
          <a:xfrm>
            <a:off x="5105400" y="108343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8</a:t>
            </a:r>
            <a:r>
              <a:rPr lang="en-US" altLang="zh-CN" sz="800" spc="-10" dirty="0" smtClean="0"/>
              <a:t>.03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00</a:t>
            </a:r>
            <a:endParaRPr lang="en-US" sz="800" spc="-10" dirty="0"/>
          </a:p>
        </p:txBody>
      </p:sp>
      <p:sp>
        <p:nvSpPr>
          <p:cNvPr id="98" name="TextBox 97"/>
          <p:cNvSpPr txBox="1"/>
          <p:nvPr/>
        </p:nvSpPr>
        <p:spPr>
          <a:xfrm>
            <a:off x="5105400" y="1603719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98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8</a:t>
            </a:r>
            <a:r>
              <a:rPr lang="en-US" altLang="zh-CN" sz="800" spc="-10" dirty="0" smtClean="0"/>
              <a:t>.05</a:t>
            </a:r>
            <a:endParaRPr lang="en-US" sz="800" spc="-10" dirty="0"/>
          </a:p>
        </p:txBody>
      </p:sp>
      <p:sp>
        <p:nvSpPr>
          <p:cNvPr id="99" name="TextBox 98"/>
          <p:cNvSpPr txBox="1"/>
          <p:nvPr/>
        </p:nvSpPr>
        <p:spPr>
          <a:xfrm>
            <a:off x="5105400" y="186386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48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40</a:t>
            </a:r>
            <a:endParaRPr lang="en-US" sz="800" spc="-10" dirty="0"/>
          </a:p>
        </p:txBody>
      </p:sp>
      <p:sp>
        <p:nvSpPr>
          <p:cNvPr id="100" name="TextBox 99"/>
          <p:cNvSpPr txBox="1"/>
          <p:nvPr/>
        </p:nvSpPr>
        <p:spPr>
          <a:xfrm>
            <a:off x="5105400" y="212400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62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62</a:t>
            </a:r>
          </a:p>
        </p:txBody>
      </p:sp>
      <p:sp>
        <p:nvSpPr>
          <p:cNvPr id="101" name="TextBox 100"/>
          <p:cNvSpPr txBox="1"/>
          <p:nvPr/>
        </p:nvSpPr>
        <p:spPr>
          <a:xfrm>
            <a:off x="5105400" y="2384142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03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73</a:t>
            </a:r>
            <a:endParaRPr lang="en-US" sz="800" spc="-10" dirty="0"/>
          </a:p>
        </p:txBody>
      </p:sp>
      <p:sp>
        <p:nvSpPr>
          <p:cNvPr id="102" name="TextBox 101"/>
          <p:cNvSpPr txBox="1"/>
          <p:nvPr/>
        </p:nvSpPr>
        <p:spPr>
          <a:xfrm>
            <a:off x="5105400" y="264428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40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90</a:t>
            </a:r>
            <a:endParaRPr lang="en-US" sz="800" spc="-10" dirty="0"/>
          </a:p>
        </p:txBody>
      </p:sp>
      <p:sp>
        <p:nvSpPr>
          <p:cNvPr id="103" name="TextBox 102"/>
          <p:cNvSpPr txBox="1"/>
          <p:nvPr/>
        </p:nvSpPr>
        <p:spPr>
          <a:xfrm>
            <a:off x="5105400" y="2904424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75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58</a:t>
            </a:r>
            <a:endParaRPr lang="en-US" sz="800" spc="-10" dirty="0"/>
          </a:p>
        </p:txBody>
      </p:sp>
      <p:sp>
        <p:nvSpPr>
          <p:cNvPr id="104" name="TextBox 103"/>
          <p:cNvSpPr txBox="1"/>
          <p:nvPr/>
        </p:nvSpPr>
        <p:spPr>
          <a:xfrm>
            <a:off x="5105400" y="316456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23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01</a:t>
            </a:r>
            <a:endParaRPr lang="en-US" sz="800" spc="-10" dirty="0"/>
          </a:p>
        </p:txBody>
      </p:sp>
      <p:sp>
        <p:nvSpPr>
          <p:cNvPr id="105" name="TextBox 104"/>
          <p:cNvSpPr txBox="1"/>
          <p:nvPr/>
        </p:nvSpPr>
        <p:spPr>
          <a:xfrm>
            <a:off x="5105400" y="3424706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86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7</a:t>
            </a:r>
            <a:r>
              <a:rPr lang="en-US" altLang="zh-CN" sz="800" spc="-10" dirty="0" smtClean="0"/>
              <a:t>.50</a:t>
            </a:r>
            <a:endParaRPr lang="en-US" sz="800" spc="-10" dirty="0"/>
          </a:p>
        </p:txBody>
      </p:sp>
      <p:sp>
        <p:nvSpPr>
          <p:cNvPr id="106" name="TextBox 105"/>
          <p:cNvSpPr txBox="1"/>
          <p:nvPr/>
        </p:nvSpPr>
        <p:spPr>
          <a:xfrm>
            <a:off x="5105400" y="368484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altLang="zh-CN" sz="800" spc="-10" dirty="0" smtClean="0"/>
              <a:t>2.67</a:t>
            </a:r>
          </a:p>
          <a:p>
            <a:pPr>
              <a:lnSpc>
                <a:spcPts val="600"/>
              </a:lnSpc>
            </a:pPr>
            <a:r>
              <a:rPr lang="en-US" altLang="zh-CN" sz="800" spc="-10" dirty="0" smtClean="0"/>
              <a:t>5.32</a:t>
            </a:r>
          </a:p>
        </p:txBody>
      </p:sp>
      <p:sp>
        <p:nvSpPr>
          <p:cNvPr id="107" name="TextBox 106"/>
          <p:cNvSpPr txBox="1"/>
          <p:nvPr/>
        </p:nvSpPr>
        <p:spPr>
          <a:xfrm>
            <a:off x="5105400" y="393710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94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40</a:t>
            </a:r>
            <a:endParaRPr lang="en-US" sz="800" spc="-10" dirty="0"/>
          </a:p>
        </p:txBody>
      </p:sp>
      <p:sp>
        <p:nvSpPr>
          <p:cNvPr id="108" name="TextBox 107"/>
          <p:cNvSpPr txBox="1"/>
          <p:nvPr/>
        </p:nvSpPr>
        <p:spPr>
          <a:xfrm>
            <a:off x="5105400" y="419724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15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07</a:t>
            </a:r>
            <a:endParaRPr lang="en-US" sz="800" spc="-10" dirty="0"/>
          </a:p>
        </p:txBody>
      </p:sp>
      <p:sp>
        <p:nvSpPr>
          <p:cNvPr id="109" name="TextBox 108"/>
          <p:cNvSpPr txBox="1"/>
          <p:nvPr/>
        </p:nvSpPr>
        <p:spPr>
          <a:xfrm>
            <a:off x="5105400" y="4457382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49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67</a:t>
            </a:r>
            <a:endParaRPr lang="en-US" sz="800" spc="-10" dirty="0"/>
          </a:p>
        </p:txBody>
      </p:sp>
      <p:sp>
        <p:nvSpPr>
          <p:cNvPr id="110" name="TextBox 109"/>
          <p:cNvSpPr txBox="1"/>
          <p:nvPr/>
        </p:nvSpPr>
        <p:spPr>
          <a:xfrm>
            <a:off x="5105400" y="471752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89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7</a:t>
            </a:r>
            <a:r>
              <a:rPr lang="en-US" altLang="zh-CN" sz="800" spc="-10" dirty="0" smtClean="0"/>
              <a:t>.24</a:t>
            </a:r>
            <a:endParaRPr lang="en-US" sz="800" spc="-10" dirty="0"/>
          </a:p>
        </p:txBody>
      </p:sp>
      <p:sp>
        <p:nvSpPr>
          <p:cNvPr id="111" name="TextBox 110"/>
          <p:cNvSpPr txBox="1"/>
          <p:nvPr/>
        </p:nvSpPr>
        <p:spPr>
          <a:xfrm>
            <a:off x="5105400" y="497766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02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22</a:t>
            </a:r>
            <a:endParaRPr lang="en-US" sz="800" spc="-10" dirty="0"/>
          </a:p>
        </p:txBody>
      </p:sp>
      <p:sp>
        <p:nvSpPr>
          <p:cNvPr id="112" name="TextBox 111"/>
          <p:cNvSpPr txBox="1"/>
          <p:nvPr/>
        </p:nvSpPr>
        <p:spPr>
          <a:xfrm>
            <a:off x="5105400" y="523780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22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6</a:t>
            </a:r>
            <a:r>
              <a:rPr lang="en-US" altLang="zh-CN" sz="800" spc="-10" dirty="0" smtClean="0"/>
              <a:t>.77</a:t>
            </a:r>
            <a:endParaRPr lang="en-US" sz="800" spc="-10" dirty="0"/>
          </a:p>
        </p:txBody>
      </p:sp>
      <p:sp>
        <p:nvSpPr>
          <p:cNvPr id="113" name="TextBox 112"/>
          <p:cNvSpPr txBox="1"/>
          <p:nvPr/>
        </p:nvSpPr>
        <p:spPr>
          <a:xfrm>
            <a:off x="5105400" y="5497946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99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94</a:t>
            </a:r>
            <a:endParaRPr lang="en-US" sz="800" spc="-10" dirty="0"/>
          </a:p>
        </p:txBody>
      </p:sp>
      <p:sp>
        <p:nvSpPr>
          <p:cNvPr id="114" name="TextBox 113"/>
          <p:cNvSpPr txBox="1"/>
          <p:nvPr/>
        </p:nvSpPr>
        <p:spPr>
          <a:xfrm>
            <a:off x="5105400" y="575808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7</a:t>
            </a:r>
            <a:r>
              <a:rPr lang="en-US" altLang="zh-CN" sz="800" spc="-10" dirty="0" smtClean="0"/>
              <a:t>.49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86</a:t>
            </a:r>
            <a:endParaRPr lang="en-US" sz="800" spc="-10" dirty="0"/>
          </a:p>
        </p:txBody>
      </p:sp>
      <p:sp>
        <p:nvSpPr>
          <p:cNvPr id="115" name="TextBox 114"/>
          <p:cNvSpPr txBox="1"/>
          <p:nvPr/>
        </p:nvSpPr>
        <p:spPr>
          <a:xfrm>
            <a:off x="5105400" y="6018229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9</a:t>
            </a:r>
            <a:r>
              <a:rPr lang="en-US" altLang="zh-CN" sz="800" spc="-10" dirty="0" smtClean="0"/>
              <a:t>.99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75</a:t>
            </a:r>
            <a:endParaRPr lang="en-US" sz="800" spc="-10" dirty="0"/>
          </a:p>
        </p:txBody>
      </p:sp>
      <p:sp>
        <p:nvSpPr>
          <p:cNvPr id="116" name="TextBox 115"/>
          <p:cNvSpPr txBox="1"/>
          <p:nvPr/>
        </p:nvSpPr>
        <p:spPr>
          <a:xfrm>
            <a:off x="5105400" y="6278369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28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85</a:t>
            </a:r>
            <a:endParaRPr lang="en-US" sz="800" spc="-10" dirty="0"/>
          </a:p>
        </p:txBody>
      </p:sp>
      <p:sp>
        <p:nvSpPr>
          <p:cNvPr id="117" name="TextBox 116"/>
          <p:cNvSpPr txBox="1"/>
          <p:nvPr/>
        </p:nvSpPr>
        <p:spPr>
          <a:xfrm>
            <a:off x="5105400" y="6538510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65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9</a:t>
            </a:r>
            <a:r>
              <a:rPr lang="en-US" altLang="zh-CN" sz="800" spc="-10" dirty="0" smtClean="0"/>
              <a:t>.69</a:t>
            </a:r>
            <a:endParaRPr lang="en-US" sz="800" spc="-10" dirty="0"/>
          </a:p>
        </p:txBody>
      </p:sp>
      <p:sp>
        <p:nvSpPr>
          <p:cNvPr id="118" name="TextBox 117"/>
          <p:cNvSpPr txBox="1"/>
          <p:nvPr/>
        </p:nvSpPr>
        <p:spPr>
          <a:xfrm>
            <a:off x="5105400" y="705879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81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51</a:t>
            </a:r>
            <a:endParaRPr lang="en-US" sz="800" spc="-10" dirty="0"/>
          </a:p>
        </p:txBody>
      </p:sp>
      <p:sp>
        <p:nvSpPr>
          <p:cNvPr id="119" name="TextBox 118"/>
          <p:cNvSpPr txBox="1"/>
          <p:nvPr/>
        </p:nvSpPr>
        <p:spPr>
          <a:xfrm>
            <a:off x="5105400" y="731893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20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48</a:t>
            </a:r>
            <a:endParaRPr lang="en-US" sz="800" spc="-10" dirty="0"/>
          </a:p>
        </p:txBody>
      </p:sp>
      <p:sp>
        <p:nvSpPr>
          <p:cNvPr id="120" name="TextBox 119"/>
          <p:cNvSpPr txBox="1"/>
          <p:nvPr/>
        </p:nvSpPr>
        <p:spPr>
          <a:xfrm>
            <a:off x="5105400" y="7579074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03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99</a:t>
            </a:r>
            <a:endParaRPr lang="en-US" sz="800" spc="-10" dirty="0"/>
          </a:p>
        </p:txBody>
      </p:sp>
      <p:sp>
        <p:nvSpPr>
          <p:cNvPr id="121" name="TextBox 120"/>
          <p:cNvSpPr txBox="1"/>
          <p:nvPr/>
        </p:nvSpPr>
        <p:spPr>
          <a:xfrm>
            <a:off x="5105400" y="8099348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51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04</a:t>
            </a:r>
            <a:endParaRPr lang="en-US" sz="800" spc="-10" dirty="0"/>
          </a:p>
        </p:txBody>
      </p:sp>
      <p:sp>
        <p:nvSpPr>
          <p:cNvPr id="122" name="TextBox 121"/>
          <p:cNvSpPr txBox="1"/>
          <p:nvPr/>
        </p:nvSpPr>
        <p:spPr>
          <a:xfrm>
            <a:off x="5105400" y="679865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24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81</a:t>
            </a:r>
            <a:endParaRPr lang="en-US" sz="800" spc="-10" dirty="0"/>
          </a:p>
        </p:txBody>
      </p:sp>
      <p:sp>
        <p:nvSpPr>
          <p:cNvPr id="123" name="TextBox 122"/>
          <p:cNvSpPr txBox="1"/>
          <p:nvPr/>
        </p:nvSpPr>
        <p:spPr>
          <a:xfrm>
            <a:off x="5105400" y="783921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7</a:t>
            </a:r>
            <a:r>
              <a:rPr lang="en-US" altLang="zh-CN" sz="800" spc="-10" dirty="0" smtClean="0"/>
              <a:t>.32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75</a:t>
            </a:r>
            <a:endParaRPr lang="en-US" sz="800" spc="-10" dirty="0"/>
          </a:p>
        </p:txBody>
      </p:sp>
      <p:pic>
        <p:nvPicPr>
          <p:cNvPr id="34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66932" y="8741371"/>
            <a:ext cx="465085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5" name="TextBox 34"/>
          <p:cNvSpPr txBox="1"/>
          <p:nvPr/>
        </p:nvSpPr>
        <p:spPr>
          <a:xfrm>
            <a:off x="36286" y="0"/>
            <a:ext cx="13314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/>
              <a:t>Figure S6</a:t>
            </a:r>
            <a:endParaRPr lang="en-US" sz="2000" b="1" dirty="0"/>
          </a:p>
        </p:txBody>
      </p:sp>
      <p:sp>
        <p:nvSpPr>
          <p:cNvPr id="37" name="TextBox 36"/>
          <p:cNvSpPr txBox="1"/>
          <p:nvPr/>
        </p:nvSpPr>
        <p:spPr>
          <a:xfrm>
            <a:off x="5029200" y="105228"/>
            <a:ext cx="800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CV (%)</a:t>
            </a:r>
            <a:endParaRPr 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7170443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9</Words>
  <Application>Microsoft Office PowerPoint</Application>
  <PresentationFormat>On-screen Show (4:3)</PresentationFormat>
  <Paragraphs>6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NG</dc:creator>
  <cp:lastModifiedBy>PENG</cp:lastModifiedBy>
  <cp:revision>1</cp:revision>
  <dcterms:created xsi:type="dcterms:W3CDTF">2006-08-16T00:00:00Z</dcterms:created>
  <dcterms:modified xsi:type="dcterms:W3CDTF">2013-03-20T09:56:55Z</dcterms:modified>
</cp:coreProperties>
</file>